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D75BD8-05EA-4577-958A-37DB0BB76E0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C00806-9A72-41CA-8B78-1ED3C1E012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15F004-719D-401B-965C-6D6D997753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371C4-E557-4364-8606-EFC3A95809F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AA8A4A-0254-4324-9EF3-579A3BA465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C8AD12-62EA-416C-8351-1FD46C9E97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FDCA81-22AE-408B-8C00-F6B0B7B6E9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F79B0F-3038-44B0-8F5B-F5F6A5A51A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0839AC-F7A0-46D2-A627-E882988E5B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4A7C3F-3C89-4096-9E73-6F2048C799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DDF06B-DC1E-4D12-90F5-E5E446AFAA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A03D77-6ADB-47CD-A35A-90233D6678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AF3BF91-67E4-4D8E-844B-D3F93960F060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1" descr=""/>
          <p:cNvPicPr/>
          <p:nvPr/>
        </p:nvPicPr>
        <p:blipFill>
          <a:blip r:embed="rId1"/>
          <a:stretch/>
        </p:blipFill>
        <p:spPr>
          <a:xfrm>
            <a:off x="343080" y="77760"/>
            <a:ext cx="3225600" cy="1589040"/>
          </a:xfrm>
          <a:prstGeom prst="rect">
            <a:avLst/>
          </a:prstGeom>
          <a:ln w="0">
            <a:noFill/>
          </a:ln>
        </p:spPr>
      </p:pic>
      <p:pic>
        <p:nvPicPr>
          <p:cNvPr id="42" name="图片 1" descr=""/>
          <p:cNvPicPr/>
          <p:nvPr/>
        </p:nvPicPr>
        <p:blipFill>
          <a:blip r:embed="rId2"/>
          <a:stretch/>
        </p:blipFill>
        <p:spPr>
          <a:xfrm>
            <a:off x="4575240" y="77760"/>
            <a:ext cx="3440160" cy="1671840"/>
          </a:xfrm>
          <a:prstGeom prst="rect">
            <a:avLst/>
          </a:prstGeom>
          <a:ln w="0">
            <a:noFill/>
          </a:ln>
        </p:spPr>
      </p:pic>
      <p:pic>
        <p:nvPicPr>
          <p:cNvPr id="43" name="图片 1" descr=""/>
          <p:cNvPicPr/>
          <p:nvPr/>
        </p:nvPicPr>
        <p:blipFill>
          <a:blip r:embed="rId3"/>
          <a:stretch/>
        </p:blipFill>
        <p:spPr>
          <a:xfrm>
            <a:off x="650880" y="1846440"/>
            <a:ext cx="2608200" cy="1550880"/>
          </a:xfrm>
          <a:prstGeom prst="rect">
            <a:avLst/>
          </a:prstGeom>
          <a:ln w="0">
            <a:noFill/>
          </a:ln>
        </p:spPr>
      </p:pic>
      <p:pic>
        <p:nvPicPr>
          <p:cNvPr id="44" name="图片 2" descr=""/>
          <p:cNvPicPr/>
          <p:nvPr/>
        </p:nvPicPr>
        <p:blipFill>
          <a:blip r:embed="rId4"/>
          <a:stretch/>
        </p:blipFill>
        <p:spPr>
          <a:xfrm>
            <a:off x="4997520" y="1846440"/>
            <a:ext cx="2593800" cy="1542960"/>
          </a:xfrm>
          <a:prstGeom prst="rect">
            <a:avLst/>
          </a:prstGeom>
          <a:ln w="0">
            <a:noFill/>
          </a:ln>
        </p:spPr>
      </p:pic>
      <p:pic>
        <p:nvPicPr>
          <p:cNvPr id="45" name="图片 2" descr=""/>
          <p:cNvPicPr/>
          <p:nvPr/>
        </p:nvPicPr>
        <p:blipFill>
          <a:blip r:embed="rId5"/>
          <a:stretch/>
        </p:blipFill>
        <p:spPr>
          <a:xfrm>
            <a:off x="741240" y="3389400"/>
            <a:ext cx="2517840" cy="1566720"/>
          </a:xfrm>
          <a:prstGeom prst="rect">
            <a:avLst/>
          </a:prstGeom>
          <a:ln w="0">
            <a:noFill/>
          </a:ln>
        </p:spPr>
      </p:pic>
      <p:pic>
        <p:nvPicPr>
          <p:cNvPr id="46" name="图片 3" descr=""/>
          <p:cNvPicPr/>
          <p:nvPr/>
        </p:nvPicPr>
        <p:blipFill>
          <a:blip r:embed="rId6"/>
          <a:stretch/>
        </p:blipFill>
        <p:spPr>
          <a:xfrm>
            <a:off x="5095800" y="3389400"/>
            <a:ext cx="2494080" cy="1569960"/>
          </a:xfrm>
          <a:prstGeom prst="rect">
            <a:avLst/>
          </a:prstGeom>
          <a:ln w="0">
            <a:noFill/>
          </a:ln>
        </p:spPr>
      </p:pic>
      <p:pic>
        <p:nvPicPr>
          <p:cNvPr id="47" name="图片 1" descr=""/>
          <p:cNvPicPr/>
          <p:nvPr/>
        </p:nvPicPr>
        <p:blipFill>
          <a:blip r:embed="rId7"/>
          <a:stretch/>
        </p:blipFill>
        <p:spPr>
          <a:xfrm>
            <a:off x="1055520" y="4959360"/>
            <a:ext cx="1797120" cy="1606680"/>
          </a:xfrm>
          <a:prstGeom prst="rect">
            <a:avLst/>
          </a:prstGeom>
          <a:ln w="0">
            <a:noFill/>
          </a:ln>
        </p:spPr>
      </p:pic>
      <p:pic>
        <p:nvPicPr>
          <p:cNvPr id="48" name="图片 2" descr=""/>
          <p:cNvPicPr/>
          <p:nvPr/>
        </p:nvPicPr>
        <p:blipFill>
          <a:blip r:embed="rId8"/>
          <a:stretch/>
        </p:blipFill>
        <p:spPr>
          <a:xfrm>
            <a:off x="5419800" y="4959360"/>
            <a:ext cx="1749240" cy="1616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文本框 1"/>
          <p:cNvSpPr/>
          <p:nvPr/>
        </p:nvSpPr>
        <p:spPr>
          <a:xfrm>
            <a:off x="838080" y="888840"/>
            <a:ext cx="7469280" cy="329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Fig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1 a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The EIC plot of positive internal standard ions in blank samples and QC sample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Fig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1 b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The EIC plot of negative internal standard ions in blank samples and QC sample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Fig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1 c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The positive ion PCA score plot. The green points were QC samples, and the blue points were formal experimental sample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Fig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1 d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The negative ion PCA score plot. The green points were QC samples, and the blue points were formal experimental sample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Fig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1 e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PCA-X one-dimensional distribution of QC samples in positive ion mode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Fig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1 f 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PCA-X one-dimensional distribution of QC samples in negative ion mode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Fig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1 g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The correlation analysis in positive ion QC sample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Fig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1 h 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The correlation analysis in negative ion QC sample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5-28T09:40:40Z</dcterms:created>
  <dc:creator>shiyu sun</dc:creator>
  <dc:description/>
  <dc:language>en-US</dc:language>
  <cp:lastModifiedBy>牛璐</cp:lastModifiedBy>
  <dcterms:modified xsi:type="dcterms:W3CDTF">2023-05-28T09:40:40Z</dcterms:modified>
  <cp:revision>1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214</vt:lpwstr>
  </property>
</Properties>
</file>